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3944A9-9AE1-4BEC-B7B7-A958DE54D8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BB523E-1350-47CD-B74B-D01EE10F01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6CEFBA-DAFD-484C-A0A9-5AE67BB2EB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55226-88B7-4008-9C96-6026EFBE78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D0E3E1-9466-437D-A3F3-E2244C1BFD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AE74B-18B7-44C4-85FF-08FCF1000E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59F41-89F0-49FB-88ED-1F836B370E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9E0321-12CA-4B34-8773-A2B11BCF88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A1BB6F-937B-4C7D-A9BA-393A73B4A6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1D7223-FBD1-46EE-BDA1-EF74DB5397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9478C-E229-41D1-9EDB-15E6B0EDD2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1353E-0BF2-4E13-AAB1-2B1DDCDE27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CF4983-0946-4286-987D-84732C293D3F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C6A102-C3D9-41AA-BE90-CE50DD1649D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"/>
          <p:cNvPicPr/>
          <p:nvPr/>
        </p:nvPicPr>
        <p:blipFill>
          <a:blip r:embed="rId1"/>
          <a:srcRect l="11804" t="0" r="4666" b="8964"/>
          <a:stretch/>
        </p:blipFill>
        <p:spPr>
          <a:xfrm>
            <a:off x="1143000" y="609480"/>
            <a:ext cx="4940280" cy="1519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3" descr=""/>
          <p:cNvPicPr/>
          <p:nvPr/>
        </p:nvPicPr>
        <p:blipFill>
          <a:blip r:embed="rId2"/>
          <a:srcRect l="11672" t="2873" r="4586" b="6068"/>
          <a:stretch/>
        </p:blipFill>
        <p:spPr>
          <a:xfrm>
            <a:off x="1135080" y="2209680"/>
            <a:ext cx="4952880" cy="1527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TextBox 5"/>
          <p:cNvSpPr/>
          <p:nvPr/>
        </p:nvSpPr>
        <p:spPr>
          <a:xfrm>
            <a:off x="4164840" y="3716280"/>
            <a:ext cx="41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2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2606040" y="3716280"/>
            <a:ext cx="41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2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1028880" y="3716280"/>
            <a:ext cx="41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5733360" y="3716280"/>
            <a:ext cx="41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2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1147680" y="606600"/>
            <a:ext cx="3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1148400" y="2214720"/>
            <a:ext cx="363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9"/>
          <p:cNvSpPr/>
          <p:nvPr/>
        </p:nvSpPr>
        <p:spPr>
          <a:xfrm>
            <a:off x="158760" y="4800600"/>
            <a:ext cx="898524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dditional file 2:  Indel Analysis by Denaturing Capillary Electrophore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alysis of 187delAG for loss of wt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CA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Internal capillary size standards labeled with ROX are show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red (201and 227 base pairs). 6-FAM labeled WT and mutant allele PCR products are shown in black. WT allele size is 216 base pai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mutant 187delAG allele size is 214 base pairs. Panel A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hows analysis of DNA heterozygous for the 187delAG mut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at was extracted from normal tissue from a BRCA1 mutation carrier. Both the wild type peak at 216 base pairs as well as the mutant peak at 214 base pairs are present at equivalent ratios. Panel B shows analysis of DNA homozygous for the 187delAG mutation that was extracted from a breast tumor. Only the mutant peak at 214 base pairs is present indicating loss of wt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BRCA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2"/>
          <p:cNvSpPr/>
          <p:nvPr/>
        </p:nvSpPr>
        <p:spPr>
          <a:xfrm>
            <a:off x="2671560" y="4114800"/>
            <a:ext cx="1668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ize (base pair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23:16:07Z</dcterms:created>
  <dc:creator>alexander miron</dc:creator>
  <dc:description/>
  <dc:language>en-US</dc:language>
  <cp:lastModifiedBy>ntung</cp:lastModifiedBy>
  <cp:lastPrinted>2010-05-04T17:17:18Z</cp:lastPrinted>
  <dcterms:modified xsi:type="dcterms:W3CDTF">2010-11-14T13:59:49Z</dcterms:modified>
  <cp:revision>15</cp:revision>
  <dc:subject/>
  <dc:title>PowerPoint Presentation</dc:title>
</cp:coreProperties>
</file>